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07200" cy="9939338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8" roundtripDataSignature="AMtx7mgUHBdeMU5FQAA01sPWF/+lCsb8M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F67073CF-102F-4DA7-9294-74CDDB67348B}">
  <a:tblStyle styleId="{F67073CF-102F-4DA7-9294-74CDDB67348B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24"/>
  </p:normalViewPr>
  <p:slideViewPr>
    <p:cSldViewPr snapToGrid="0" showGuides="1">
      <p:cViewPr varScale="1">
        <p:scale>
          <a:sx n="107" d="100"/>
          <a:sy n="107" d="100"/>
        </p:scale>
        <p:origin x="1688" y="1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customschemas.google.com/relationships/presentationmetadata" Target="metadata"/><Relationship Id="rId3" Type="http://schemas.openxmlformats.org/officeDocument/2006/relationships/notesMaster" Target="notesMasters/notesMaster1.xml"/><Relationship Id="rId21" Type="http://schemas.openxmlformats.org/officeDocument/2006/relationships/theme" Target="theme/theme1.xml"/><Relationship Id="rId2" Type="http://schemas.openxmlformats.org/officeDocument/2006/relationships/slide" Target="slides/slide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23" Type="http://schemas.microsoft.com/office/2016/11/relationships/changesInfo" Target="changesInfos/changesInfo1.xml"/><Relationship Id="rId19" Type="http://schemas.openxmlformats.org/officeDocument/2006/relationships/presProps" Target="presProps.xml"/><Relationship Id="rId22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将大 木村" userId="5c8554e9327f43b8" providerId="LiveId" clId="{4F756BF4-88B1-43BA-B32E-29E45B4CF4F5}"/>
    <pc:docChg chg="custSel modSld">
      <pc:chgData name="将大 木村" userId="5c8554e9327f43b8" providerId="LiveId" clId="{4F756BF4-88B1-43BA-B32E-29E45B4CF4F5}" dt="2026-03-11T14:07:20.938" v="0" actId="478"/>
      <pc:docMkLst>
        <pc:docMk/>
      </pc:docMkLst>
      <pc:sldChg chg="delSp mod">
        <pc:chgData name="将大 木村" userId="5c8554e9327f43b8" providerId="LiveId" clId="{4F756BF4-88B1-43BA-B32E-29E45B4CF4F5}" dt="2026-03-11T14:07:20.938" v="0" actId="478"/>
        <pc:sldMkLst>
          <pc:docMk/>
          <pc:sldMk cId="0" sldId="257"/>
        </pc:sldMkLst>
        <pc:spChg chg="del">
          <ac:chgData name="将大 木村" userId="5c8554e9327f43b8" providerId="LiveId" clId="{4F756BF4-88B1-43BA-B32E-29E45B4CF4F5}" dt="2026-03-11T14:07:20.938" v="0" actId="478"/>
          <ac:spMkLst>
            <pc:docMk/>
            <pc:sldMk cId="0" sldId="257"/>
            <ac:spMk id="171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34750" y="745425"/>
            <a:ext cx="4538350" cy="37272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0700" y="4721175"/>
            <a:ext cx="5445750" cy="4472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p2:notes"/>
          <p:cNvSpPr txBox="1">
            <a:spLocks noGrp="1"/>
          </p:cNvSpPr>
          <p:nvPr>
            <p:ph type="body" idx="1"/>
          </p:nvPr>
        </p:nvSpPr>
        <p:spPr>
          <a:xfrm>
            <a:off x="680700" y="4721175"/>
            <a:ext cx="5445750" cy="4472675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69" name="Google Shape;169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7288" cy="3725863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4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14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1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1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1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3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3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4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4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1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5"/>
          <p:cNvSpPr txBox="1"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5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15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5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5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1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2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1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21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2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2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2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2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22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2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3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3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E9EFC00-395D-51EA-D947-96E47D6A7EB1}"/>
              </a:ext>
            </a:extLst>
          </p:cNvPr>
          <p:cNvGrpSpPr/>
          <p:nvPr/>
        </p:nvGrpSpPr>
        <p:grpSpPr>
          <a:xfrm>
            <a:off x="1855935" y="964630"/>
            <a:ext cx="4596683" cy="3564995"/>
            <a:chOff x="1855935" y="1368387"/>
            <a:chExt cx="4596683" cy="3564995"/>
          </a:xfrm>
        </p:grpSpPr>
        <p:grpSp>
          <p:nvGrpSpPr>
            <p:cNvPr id="24" name="Group 24">
              <a:extLst>
                <a:ext uri="{FF2B5EF4-FFF2-40B4-BE49-F238E27FC236}">
                  <a16:creationId xmlns:a16="http://schemas.microsoft.com/office/drawing/2014/main" id="{4CD522D3-626A-4734-F022-750339687309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2213993" y="1478982"/>
              <a:ext cx="4238625" cy="3454400"/>
              <a:chOff x="3111" y="840"/>
              <a:chExt cx="2670" cy="2176"/>
            </a:xfrm>
          </p:grpSpPr>
          <p:sp>
            <p:nvSpPr>
              <p:cNvPr id="25" name="AutoShape 23">
                <a:extLst>
                  <a:ext uri="{FF2B5EF4-FFF2-40B4-BE49-F238E27FC236}">
                    <a16:creationId xmlns:a16="http://schemas.microsoft.com/office/drawing/2014/main" id="{72D78062-D850-EFC5-DFB4-121EBB18E632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3111" y="840"/>
                <a:ext cx="2670" cy="21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76FD88BF-58C2-29F9-6755-B40C8D1594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1" y="840"/>
                <a:ext cx="2670" cy="2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DB75B298-F98E-8C9C-E1E5-D6DE377FD2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5" y="1628"/>
                <a:ext cx="298" cy="1045"/>
              </a:xfrm>
              <a:prstGeom prst="rect">
                <a:avLst/>
              </a:prstGeom>
              <a:solidFill>
                <a:srgbClr val="0F9ED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" name="Freeform 27">
                <a:extLst>
                  <a:ext uri="{FF2B5EF4-FFF2-40B4-BE49-F238E27FC236}">
                    <a16:creationId xmlns:a16="http://schemas.microsoft.com/office/drawing/2014/main" id="{32A51EAA-0E91-D0A6-A031-849BC356208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691" y="1134"/>
                <a:ext cx="1045" cy="1539"/>
              </a:xfrm>
              <a:custGeom>
                <a:avLst/>
                <a:gdLst>
                  <a:gd name="T0" fmla="*/ 0 w 1045"/>
                  <a:gd name="T1" fmla="*/ 0 h 1539"/>
                  <a:gd name="T2" fmla="*/ 299 w 1045"/>
                  <a:gd name="T3" fmla="*/ 0 h 1539"/>
                  <a:gd name="T4" fmla="*/ 299 w 1045"/>
                  <a:gd name="T5" fmla="*/ 1539 h 1539"/>
                  <a:gd name="T6" fmla="*/ 0 w 1045"/>
                  <a:gd name="T7" fmla="*/ 1539 h 1539"/>
                  <a:gd name="T8" fmla="*/ 0 w 1045"/>
                  <a:gd name="T9" fmla="*/ 0 h 1539"/>
                  <a:gd name="T10" fmla="*/ 747 w 1045"/>
                  <a:gd name="T11" fmla="*/ 64 h 1539"/>
                  <a:gd name="T12" fmla="*/ 1045 w 1045"/>
                  <a:gd name="T13" fmla="*/ 64 h 1539"/>
                  <a:gd name="T14" fmla="*/ 1045 w 1045"/>
                  <a:gd name="T15" fmla="*/ 1539 h 1539"/>
                  <a:gd name="T16" fmla="*/ 747 w 1045"/>
                  <a:gd name="T17" fmla="*/ 1539 h 1539"/>
                  <a:gd name="T18" fmla="*/ 747 w 1045"/>
                  <a:gd name="T19" fmla="*/ 64 h 15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045" h="1539">
                    <a:moveTo>
                      <a:pt x="0" y="0"/>
                    </a:moveTo>
                    <a:lnTo>
                      <a:pt x="299" y="0"/>
                    </a:lnTo>
                    <a:lnTo>
                      <a:pt x="299" y="1539"/>
                    </a:lnTo>
                    <a:lnTo>
                      <a:pt x="0" y="1539"/>
                    </a:lnTo>
                    <a:lnTo>
                      <a:pt x="0" y="0"/>
                    </a:lnTo>
                    <a:close/>
                    <a:moveTo>
                      <a:pt x="747" y="64"/>
                    </a:moveTo>
                    <a:lnTo>
                      <a:pt x="1045" y="64"/>
                    </a:lnTo>
                    <a:lnTo>
                      <a:pt x="1045" y="1539"/>
                    </a:lnTo>
                    <a:lnTo>
                      <a:pt x="747" y="1539"/>
                    </a:lnTo>
                    <a:lnTo>
                      <a:pt x="747" y="64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" name="Freeform 28">
                <a:extLst>
                  <a:ext uri="{FF2B5EF4-FFF2-40B4-BE49-F238E27FC236}">
                    <a16:creationId xmlns:a16="http://schemas.microsoft.com/office/drawing/2014/main" id="{D6125EAF-6F11-0CFA-1827-489B27C3A83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822" y="1079"/>
                <a:ext cx="36" cy="111"/>
              </a:xfrm>
              <a:custGeom>
                <a:avLst/>
                <a:gdLst>
                  <a:gd name="T0" fmla="*/ 18 w 36"/>
                  <a:gd name="T1" fmla="*/ 55 h 111"/>
                  <a:gd name="T2" fmla="*/ 18 w 36"/>
                  <a:gd name="T3" fmla="*/ 111 h 111"/>
                  <a:gd name="T4" fmla="*/ 18 w 36"/>
                  <a:gd name="T5" fmla="*/ 55 h 111"/>
                  <a:gd name="T6" fmla="*/ 18 w 36"/>
                  <a:gd name="T7" fmla="*/ 0 h 111"/>
                  <a:gd name="T8" fmla="*/ 0 w 36"/>
                  <a:gd name="T9" fmla="*/ 111 h 111"/>
                  <a:gd name="T10" fmla="*/ 36 w 36"/>
                  <a:gd name="T11" fmla="*/ 111 h 111"/>
                  <a:gd name="T12" fmla="*/ 0 w 36"/>
                  <a:gd name="T13" fmla="*/ 0 h 111"/>
                  <a:gd name="T14" fmla="*/ 36 w 36"/>
                  <a:gd name="T15" fmla="*/ 0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6" h="111">
                    <a:moveTo>
                      <a:pt x="18" y="55"/>
                    </a:moveTo>
                    <a:lnTo>
                      <a:pt x="18" y="111"/>
                    </a:lnTo>
                    <a:moveTo>
                      <a:pt x="18" y="55"/>
                    </a:moveTo>
                    <a:lnTo>
                      <a:pt x="18" y="0"/>
                    </a:lnTo>
                    <a:moveTo>
                      <a:pt x="0" y="111"/>
                    </a:moveTo>
                    <a:lnTo>
                      <a:pt x="36" y="111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" name="Freeform 29">
                <a:extLst>
                  <a:ext uri="{FF2B5EF4-FFF2-40B4-BE49-F238E27FC236}">
                    <a16:creationId xmlns:a16="http://schemas.microsoft.com/office/drawing/2014/main" id="{E66BD6AC-B725-D3E1-B725-B2FD699FBDF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569" y="1066"/>
                <a:ext cx="36" cy="263"/>
              </a:xfrm>
              <a:custGeom>
                <a:avLst/>
                <a:gdLst>
                  <a:gd name="T0" fmla="*/ 18 w 36"/>
                  <a:gd name="T1" fmla="*/ 132 h 263"/>
                  <a:gd name="T2" fmla="*/ 18 w 36"/>
                  <a:gd name="T3" fmla="*/ 263 h 263"/>
                  <a:gd name="T4" fmla="*/ 18 w 36"/>
                  <a:gd name="T5" fmla="*/ 132 h 263"/>
                  <a:gd name="T6" fmla="*/ 18 w 36"/>
                  <a:gd name="T7" fmla="*/ 0 h 263"/>
                  <a:gd name="T8" fmla="*/ 0 w 36"/>
                  <a:gd name="T9" fmla="*/ 263 h 263"/>
                  <a:gd name="T10" fmla="*/ 36 w 36"/>
                  <a:gd name="T11" fmla="*/ 263 h 263"/>
                  <a:gd name="T12" fmla="*/ 0 w 36"/>
                  <a:gd name="T13" fmla="*/ 0 h 263"/>
                  <a:gd name="T14" fmla="*/ 36 w 36"/>
                  <a:gd name="T15" fmla="*/ 0 h 2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6" h="263">
                    <a:moveTo>
                      <a:pt x="18" y="132"/>
                    </a:moveTo>
                    <a:lnTo>
                      <a:pt x="18" y="263"/>
                    </a:lnTo>
                    <a:moveTo>
                      <a:pt x="18" y="132"/>
                    </a:moveTo>
                    <a:lnTo>
                      <a:pt x="18" y="0"/>
                    </a:lnTo>
                    <a:moveTo>
                      <a:pt x="0" y="263"/>
                    </a:moveTo>
                    <a:lnTo>
                      <a:pt x="36" y="263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" name="Freeform 30">
                <a:extLst>
                  <a:ext uri="{FF2B5EF4-FFF2-40B4-BE49-F238E27FC236}">
                    <a16:creationId xmlns:a16="http://schemas.microsoft.com/office/drawing/2014/main" id="{5680DE25-9121-5509-97E6-91789FD1743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315" y="1546"/>
                <a:ext cx="37" cy="165"/>
              </a:xfrm>
              <a:custGeom>
                <a:avLst/>
                <a:gdLst>
                  <a:gd name="T0" fmla="*/ 19 w 37"/>
                  <a:gd name="T1" fmla="*/ 82 h 165"/>
                  <a:gd name="T2" fmla="*/ 19 w 37"/>
                  <a:gd name="T3" fmla="*/ 165 h 165"/>
                  <a:gd name="T4" fmla="*/ 19 w 37"/>
                  <a:gd name="T5" fmla="*/ 82 h 165"/>
                  <a:gd name="T6" fmla="*/ 19 w 37"/>
                  <a:gd name="T7" fmla="*/ 0 h 165"/>
                  <a:gd name="T8" fmla="*/ 0 w 37"/>
                  <a:gd name="T9" fmla="*/ 165 h 165"/>
                  <a:gd name="T10" fmla="*/ 37 w 37"/>
                  <a:gd name="T11" fmla="*/ 165 h 165"/>
                  <a:gd name="T12" fmla="*/ 0 w 37"/>
                  <a:gd name="T13" fmla="*/ 0 h 165"/>
                  <a:gd name="T14" fmla="*/ 37 w 37"/>
                  <a:gd name="T15" fmla="*/ 0 h 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7" h="165">
                    <a:moveTo>
                      <a:pt x="19" y="82"/>
                    </a:moveTo>
                    <a:lnTo>
                      <a:pt x="19" y="165"/>
                    </a:lnTo>
                    <a:moveTo>
                      <a:pt x="19" y="82"/>
                    </a:moveTo>
                    <a:lnTo>
                      <a:pt x="19" y="0"/>
                    </a:lnTo>
                    <a:moveTo>
                      <a:pt x="0" y="165"/>
                    </a:moveTo>
                    <a:lnTo>
                      <a:pt x="37" y="165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4" name="Line 31">
                <a:extLst>
                  <a:ext uri="{FF2B5EF4-FFF2-40B4-BE49-F238E27FC236}">
                    <a16:creationId xmlns:a16="http://schemas.microsoft.com/office/drawing/2014/main" id="{3276B2B0-B426-453E-B973-CE28BBD619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7" y="981"/>
                <a:ext cx="0" cy="1693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6" name="Freeform 32">
                <a:extLst>
                  <a:ext uri="{FF2B5EF4-FFF2-40B4-BE49-F238E27FC236}">
                    <a16:creationId xmlns:a16="http://schemas.microsoft.com/office/drawing/2014/main" id="{C20FD76C-243B-203D-6D46-BB54AAAD361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429" y="1135"/>
                <a:ext cx="38" cy="1539"/>
              </a:xfrm>
              <a:custGeom>
                <a:avLst/>
                <a:gdLst>
                  <a:gd name="T0" fmla="*/ 0 w 38"/>
                  <a:gd name="T1" fmla="*/ 1539 h 1539"/>
                  <a:gd name="T2" fmla="*/ 38 w 38"/>
                  <a:gd name="T3" fmla="*/ 1539 h 1539"/>
                  <a:gd name="T4" fmla="*/ 0 w 38"/>
                  <a:gd name="T5" fmla="*/ 1230 h 1539"/>
                  <a:gd name="T6" fmla="*/ 38 w 38"/>
                  <a:gd name="T7" fmla="*/ 1230 h 1539"/>
                  <a:gd name="T8" fmla="*/ 0 w 38"/>
                  <a:gd name="T9" fmla="*/ 923 h 1539"/>
                  <a:gd name="T10" fmla="*/ 38 w 38"/>
                  <a:gd name="T11" fmla="*/ 923 h 1539"/>
                  <a:gd name="T12" fmla="*/ 0 w 38"/>
                  <a:gd name="T13" fmla="*/ 615 h 1539"/>
                  <a:gd name="T14" fmla="*/ 38 w 38"/>
                  <a:gd name="T15" fmla="*/ 615 h 1539"/>
                  <a:gd name="T16" fmla="*/ 0 w 38"/>
                  <a:gd name="T17" fmla="*/ 307 h 1539"/>
                  <a:gd name="T18" fmla="*/ 38 w 38"/>
                  <a:gd name="T19" fmla="*/ 307 h 1539"/>
                  <a:gd name="T20" fmla="*/ 0 w 38"/>
                  <a:gd name="T21" fmla="*/ 0 h 1539"/>
                  <a:gd name="T22" fmla="*/ 38 w 38"/>
                  <a:gd name="T23" fmla="*/ 0 h 15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8" h="1539">
                    <a:moveTo>
                      <a:pt x="0" y="1539"/>
                    </a:moveTo>
                    <a:lnTo>
                      <a:pt x="38" y="1539"/>
                    </a:lnTo>
                    <a:moveTo>
                      <a:pt x="0" y="1230"/>
                    </a:moveTo>
                    <a:lnTo>
                      <a:pt x="38" y="1230"/>
                    </a:lnTo>
                    <a:moveTo>
                      <a:pt x="0" y="923"/>
                    </a:moveTo>
                    <a:lnTo>
                      <a:pt x="38" y="923"/>
                    </a:lnTo>
                    <a:moveTo>
                      <a:pt x="0" y="615"/>
                    </a:moveTo>
                    <a:lnTo>
                      <a:pt x="38" y="615"/>
                    </a:lnTo>
                    <a:moveTo>
                      <a:pt x="0" y="307"/>
                    </a:moveTo>
                    <a:lnTo>
                      <a:pt x="38" y="307"/>
                    </a:lnTo>
                    <a:moveTo>
                      <a:pt x="0" y="0"/>
                    </a:moveTo>
                    <a:lnTo>
                      <a:pt x="38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7" name="Line 33">
                <a:extLst>
                  <a:ext uri="{FF2B5EF4-FFF2-40B4-BE49-F238E27FC236}">
                    <a16:creationId xmlns:a16="http://schemas.microsoft.com/office/drawing/2014/main" id="{2A5EE969-180C-9343-8DBE-E836C39E90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7" y="2674"/>
                <a:ext cx="2240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8" name="Rectangle 34">
                <a:extLst>
                  <a:ext uri="{FF2B5EF4-FFF2-40B4-BE49-F238E27FC236}">
                    <a16:creationId xmlns:a16="http://schemas.microsoft.com/office/drawing/2014/main" id="{D470D0EC-118A-FB13-4411-D2519133C8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86" y="2600"/>
                <a:ext cx="128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" name="Rectangle 35">
                <a:extLst>
                  <a:ext uri="{FF2B5EF4-FFF2-40B4-BE49-F238E27FC236}">
                    <a16:creationId xmlns:a16="http://schemas.microsoft.com/office/drawing/2014/main" id="{422FD10B-DB10-0D45-CD63-2CB239A233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5" y="2292"/>
                <a:ext cx="19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" name="Rectangle 36">
                <a:extLst>
                  <a:ext uri="{FF2B5EF4-FFF2-40B4-BE49-F238E27FC236}">
                    <a16:creationId xmlns:a16="http://schemas.microsoft.com/office/drawing/2014/main" id="{CD761A0D-D095-2F1A-90C0-A34A78FF7C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5" y="1984"/>
                <a:ext cx="19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" name="Rectangle 37">
                <a:extLst>
                  <a:ext uri="{FF2B5EF4-FFF2-40B4-BE49-F238E27FC236}">
                    <a16:creationId xmlns:a16="http://schemas.microsoft.com/office/drawing/2014/main" id="{57DA44C1-140F-243C-7BFC-A05245E120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5" y="1675"/>
                <a:ext cx="19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" name="Rectangle 38">
                <a:extLst>
                  <a:ext uri="{FF2B5EF4-FFF2-40B4-BE49-F238E27FC236}">
                    <a16:creationId xmlns:a16="http://schemas.microsoft.com/office/drawing/2014/main" id="{65F7B88B-04AD-1A17-838A-A63B502045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5" y="1369"/>
                <a:ext cx="19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" name="Rectangle 39">
                <a:extLst>
                  <a:ext uri="{FF2B5EF4-FFF2-40B4-BE49-F238E27FC236}">
                    <a16:creationId xmlns:a16="http://schemas.microsoft.com/office/drawing/2014/main" id="{83DD66AE-51E8-3E4C-E419-66F9F0E7ED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44" y="1061"/>
                <a:ext cx="269" cy="1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" name="Rectangle 40">
                <a:extLst>
                  <a:ext uri="{FF2B5EF4-FFF2-40B4-BE49-F238E27FC236}">
                    <a16:creationId xmlns:a16="http://schemas.microsoft.com/office/drawing/2014/main" id="{8E110EE8-EBF4-CFEC-FCE0-953C2AE163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98" y="2751"/>
                <a:ext cx="308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one</a:t>
                </a:r>
                <a:endParaRPr kumimoji="0" lang="ja-JP" altLang="ja-JP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9" name="Rectangle 41">
                <a:extLst>
                  <a:ext uri="{FF2B5EF4-FFF2-40B4-BE49-F238E27FC236}">
                    <a16:creationId xmlns:a16="http://schemas.microsoft.com/office/drawing/2014/main" id="{00F85249-BF58-DBB5-3A5D-96D467EECC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77" y="2751"/>
                <a:ext cx="236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LF</a:t>
                </a:r>
                <a:endParaRPr kumimoji="0" lang="ja-JP" altLang="ja-JP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0" name="Rectangle 42">
                <a:extLst>
                  <a:ext uri="{FF2B5EF4-FFF2-40B4-BE49-F238E27FC236}">
                    <a16:creationId xmlns:a16="http://schemas.microsoft.com/office/drawing/2014/main" id="{0E2FF4CB-56BE-570B-F198-50FB541EE4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71" y="2751"/>
                <a:ext cx="551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LF-HSA</a:t>
                </a:r>
                <a:endParaRPr kumimoji="0" lang="ja-JP" altLang="ja-JP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98BFAB56-F0D2-B7BF-5448-9CFC91890383}"/>
                </a:ext>
              </a:extLst>
            </p:cNvPr>
            <p:cNvGrpSpPr/>
            <p:nvPr/>
          </p:nvGrpSpPr>
          <p:grpSpPr>
            <a:xfrm>
              <a:off x="1855935" y="1368387"/>
              <a:ext cx="4596683" cy="3487144"/>
              <a:chOff x="1855935" y="1368387"/>
              <a:chExt cx="4596683" cy="3487144"/>
            </a:xfrm>
          </p:grpSpPr>
          <p:sp>
            <p:nvSpPr>
              <p:cNvPr id="33" name="AutoShape 23">
                <a:extLst>
                  <a:ext uri="{FF2B5EF4-FFF2-40B4-BE49-F238E27FC236}">
                    <a16:creationId xmlns:a16="http://schemas.microsoft.com/office/drawing/2014/main" id="{B2F8B67D-2503-6AB4-AEAE-A8B51AF43872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2213993" y="1692325"/>
                <a:ext cx="4238625" cy="30710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5" name="Google Shape;175;p2"/>
              <p:cNvSpPr txBox="1"/>
              <p:nvPr/>
            </p:nvSpPr>
            <p:spPr>
              <a:xfrm>
                <a:off x="5532481" y="2062531"/>
                <a:ext cx="410854" cy="36929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800" b="1" dirty="0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**</a:t>
                </a:r>
                <a:endParaRPr sz="1800" b="1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29" name="Google Shape;841;p8">
                <a:extLst>
                  <a:ext uri="{FF2B5EF4-FFF2-40B4-BE49-F238E27FC236}">
                    <a16:creationId xmlns:a16="http://schemas.microsoft.com/office/drawing/2014/main" id="{5C150781-9D7F-2E7B-E64A-67DAE72D99E4}"/>
                  </a:ext>
                </a:extLst>
              </p:cNvPr>
              <p:cNvSpPr txBox="1"/>
              <p:nvPr/>
            </p:nvSpPr>
            <p:spPr>
              <a:xfrm>
                <a:off x="4365573" y="1368387"/>
                <a:ext cx="335173" cy="22119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51425" tIns="25700" rIns="51425" bIns="2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b="1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ns</a:t>
                </a:r>
                <a:endParaRPr sz="11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51" name="Google Shape;841;p8">
                <a:extLst>
                  <a:ext uri="{FF2B5EF4-FFF2-40B4-BE49-F238E27FC236}">
                    <a16:creationId xmlns:a16="http://schemas.microsoft.com/office/drawing/2014/main" id="{F1C894D8-0E70-52EA-BFC2-14BC3CC3BA30}"/>
                  </a:ext>
                </a:extLst>
              </p:cNvPr>
              <p:cNvSpPr txBox="1"/>
              <p:nvPr/>
            </p:nvSpPr>
            <p:spPr>
              <a:xfrm>
                <a:off x="4294503" y="1601225"/>
                <a:ext cx="491390" cy="22117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51425" tIns="25700" rIns="51425" bIns="2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altLang="ja-JP" sz="1100" b="1" dirty="0">
                    <a:solidFill>
                      <a:schemeClr val="dk1"/>
                    </a:solidFill>
                  </a:rPr>
                  <a:t>95.9</a:t>
                </a:r>
                <a:endParaRPr sz="11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52" name="Google Shape;841;p8">
                <a:extLst>
                  <a:ext uri="{FF2B5EF4-FFF2-40B4-BE49-F238E27FC236}">
                    <a16:creationId xmlns:a16="http://schemas.microsoft.com/office/drawing/2014/main" id="{283AC02F-0196-167C-5F50-F12054A2C350}"/>
                  </a:ext>
                </a:extLst>
              </p:cNvPr>
              <p:cNvSpPr txBox="1"/>
              <p:nvPr/>
            </p:nvSpPr>
            <p:spPr>
              <a:xfrm>
                <a:off x="5479572" y="2292726"/>
                <a:ext cx="491390" cy="22117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51425" tIns="25700" rIns="51425" bIns="2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altLang="ja-JP" sz="1100" b="1" dirty="0">
                    <a:solidFill>
                      <a:schemeClr val="dk1"/>
                    </a:solidFill>
                  </a:rPr>
                  <a:t>67.9</a:t>
                </a:r>
                <a:endParaRPr sz="11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53" name="Google Shape;332;p6">
                <a:extLst>
                  <a:ext uri="{FF2B5EF4-FFF2-40B4-BE49-F238E27FC236}">
                    <a16:creationId xmlns:a16="http://schemas.microsoft.com/office/drawing/2014/main" id="{D4B6D7DF-70D6-F7AE-03D0-D8CBE83C1C78}"/>
                  </a:ext>
                </a:extLst>
              </p:cNvPr>
              <p:cNvSpPr/>
              <p:nvPr/>
            </p:nvSpPr>
            <p:spPr>
              <a:xfrm rot="16200000">
                <a:off x="438881" y="3130699"/>
                <a:ext cx="3141886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2000" b="1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Growth (% of control)</a:t>
                </a:r>
                <a:endParaRPr sz="20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</p:grp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A92A5F6F-3F75-97AA-2002-730E31F48C61}"/>
              </a:ext>
            </a:extLst>
          </p:cNvPr>
          <p:cNvSpPr txBox="1"/>
          <p:nvPr/>
        </p:nvSpPr>
        <p:spPr>
          <a:xfrm>
            <a:off x="1515683" y="4530783"/>
            <a:ext cx="6370125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i="0" dirty="0">
                <a:solidFill>
                  <a:srgbClr val="1F1F1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. S1. Growth-inhibitory effects of </a:t>
            </a:r>
            <a:r>
              <a:rPr lang="en-US" altLang="ja-JP" sz="1600" b="1" i="0" dirty="0" err="1">
                <a:solidFill>
                  <a:srgbClr val="1F1F1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LF</a:t>
            </a:r>
            <a:r>
              <a:rPr lang="en-US" altLang="ja-JP" sz="1600" b="1" i="0" dirty="0">
                <a:solidFill>
                  <a:srgbClr val="1F1F1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600" b="1" i="0" dirty="0" err="1">
                <a:solidFill>
                  <a:srgbClr val="1F1F1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LF</a:t>
            </a:r>
            <a:r>
              <a:rPr lang="en-US" altLang="ja-JP" sz="1600" b="1" i="0" dirty="0">
                <a:solidFill>
                  <a:srgbClr val="1F1F1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HSA at 48 h.</a:t>
            </a:r>
          </a:p>
          <a:p>
            <a:endParaRPr lang="en-US" altLang="ja-JP" dirty="0"/>
          </a:p>
          <a:p>
            <a:r>
              <a:rPr lang="en-US" altLang="ja-JP" dirty="0"/>
              <a:t>PC-14 cells were seeded in 96-well plates at a density of 1.5 × 10⁴ cells per well and incubated overnight. Subsequently, the culture medium was replaced with RPMI-1640 medium supplemented with 10% FBS and 5 µM </a:t>
            </a:r>
            <a:r>
              <a:rPr lang="en-US" altLang="ja-JP" dirty="0" err="1"/>
              <a:t>hLF</a:t>
            </a:r>
            <a:r>
              <a:rPr lang="en-US" altLang="ja-JP" dirty="0"/>
              <a:t> or </a:t>
            </a:r>
            <a:r>
              <a:rPr lang="en-US" altLang="ja-JP" dirty="0" err="1"/>
              <a:t>hLF</a:t>
            </a:r>
            <a:r>
              <a:rPr lang="en-US" altLang="ja-JP" dirty="0"/>
              <a:t>-HSA, and the cells were cultured at 37°C in a 5% CO₂ incubator for 48 h. Cell proliferation was analyzed using the Cell Counting Kit-8 (</a:t>
            </a:r>
            <a:r>
              <a:rPr lang="en-US" altLang="ja-JP" dirty="0" err="1"/>
              <a:t>Dojindo</a:t>
            </a:r>
            <a:r>
              <a:rPr lang="en-US" altLang="ja-JP" dirty="0"/>
              <a:t> Laboratories). Data are presented as the mean ± SD (n = 3); ns, not significant; **, p &lt; 0.01 (vs none, Dunnett's test).</a:t>
            </a:r>
            <a:endParaRPr lang="ja-JP" altLang="ja-JP"/>
          </a:p>
          <a:p>
            <a:endParaRPr lang="en-US" altLang="ja-JP" sz="1600" b="1" i="0" dirty="0">
              <a:solidFill>
                <a:srgbClr val="1F1F1F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2</TotalTime>
  <Words>140</Words>
  <Application>Microsoft Macintosh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P</dc:creator>
  <cp:lastModifiedBy>佐藤 淳</cp:lastModifiedBy>
  <cp:revision>56</cp:revision>
  <dcterms:created xsi:type="dcterms:W3CDTF">2024-08-02T07:36:17Z</dcterms:created>
  <dcterms:modified xsi:type="dcterms:W3CDTF">2026-03-13T06:06:42Z</dcterms:modified>
</cp:coreProperties>
</file>